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0E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5359" autoAdjust="0"/>
  </p:normalViewPr>
  <p:slideViewPr>
    <p:cSldViewPr snapToGrid="0">
      <p:cViewPr>
        <p:scale>
          <a:sx n="200" d="100"/>
          <a:sy n="200" d="100"/>
        </p:scale>
        <p:origin x="34" y="-650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B128E-DFF1-4532-ACCD-73005988AA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F3D8A-F60E-4915-9BA1-9C2A28299E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895E81-22A1-45EB-9B6B-51F6C5FC73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BE6B52-3E9D-4106-8953-76A34D48D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DD0F6F-7D94-4077-B3AE-E0FF8AF7A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8281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0580A4-4105-4622-BCDE-40162C9178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AC9F18-0F67-409B-A8CF-E03DCC39D7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ACBD7C-D204-4256-8D45-C20E51558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9DF953-9B3B-424D-928B-BCC3CA0BB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89FFC9-8F76-489A-BB21-5837E511C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935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20CE2D-0F1A-4E5D-B9CC-D7FCE69287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D3F11D-7057-4B7D-A932-5BCD5DBB26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CD8DF5-F027-47EA-BD46-02A730D17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165D29-0339-4EEC-B244-C7519FC4B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6D0E89-E5C1-4B7F-A10A-DF13EA21D6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495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EA2960-9C54-4764-AC7F-E62BB0FBDD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CE4136-C7E2-4905-B057-335E6739EF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15CD13-809B-42B3-A3B1-D63264843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F8DB08-E9EE-4C7D-BDFD-CABD7AD59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B2447-D414-4D66-95BE-B72E62626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872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D5D10A-55F0-414E-B129-48C352C89D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771740-278D-4298-96A3-E57FD823AC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BF7040-CD0B-4DB5-9FAB-3194E6861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C271D6-0033-44A0-9B87-53AFB8205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2A5991-B123-4893-8A5F-89F82CA7E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3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F8FFD1-ECC4-4878-9EE4-828030C6E4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2C64AF-03C8-4F64-96CB-B494842A9A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700393-CBA2-40F6-9535-75C6C47FBB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943BF5-17C9-4E54-980D-06BFD6DB8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E93D68-9624-4F85-888D-1862BD205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0DC2FA-06D5-4D17-B0DF-ACD9AB5E5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494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9D7A15-6AE7-4A8D-BC2F-38C350EAF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D60E54-BDC0-4604-919E-24FA24E330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BD86CC-9888-40CF-B640-9B27EF7228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E4871B-20E3-4F35-B1AD-B6C2CE2E47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D894137-912A-4E7A-83D5-EFC736FBD1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FB147B-6FEE-46C6-B624-DE92CB472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3886BE-07C7-41A1-94D4-D2CA17CA9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D20204-78F8-46A2-8163-18D64CDE68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916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B5C881-2EC0-44A2-8468-8ACBF86089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B75C49-30D3-41BC-90E7-0B637113E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1626603-BBEC-455B-A452-CDC07F609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C2EDDEA-712A-49C9-A096-6EDDE1BFD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584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ED52220-EAA1-455B-872D-74FBF4B9E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A8A9741-35AA-44E8-B761-0571A2D77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7BC40EC-89E8-4313-A67F-42B46EF8D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385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42E956-7130-42CA-8A3C-76A0900779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0A0138-7929-4D82-B670-716E4F269C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AED0BB-38FB-400A-845D-336557FD4D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F675C5-C147-4869-8F21-C4E6B07F4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3B4850-BB7F-4A27-AA0F-F472E279F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A58174-47FA-4A86-AF67-8F657BEBD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3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54C0F-0AE1-4564-BEFB-5CA4F19DE9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34219E1-703F-4BA7-9C4F-D19EF5FF02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640416-DF14-4EEA-9347-072CFF4F55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E9BF36-04DB-419E-8087-12D92BF19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B331C68-61B1-4A82-9841-99AD5832A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B5D840-3D63-408A-9045-229259B74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743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E79C61-CE52-4E47-B798-7190507B8C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3E3F6F-2E33-42DB-9D2D-FDC8445EB3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2EF39-308B-452D-A977-6D1AFA556A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E9EBAF-27D9-4F52-8815-9709FC88E5AA}" type="datetimeFigureOut">
              <a:rPr lang="en-US" smtClean="0"/>
              <a:t>5/1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C980D4-B885-4ABA-9333-8CF687C5CA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E84476-B0E1-46D0-865E-B59AE23DCA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5CF1E3-0B61-4F84-A043-5837364AA0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7946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id="{9993F8C5-1A94-4CA0-AD53-9BB591878C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748" y="642216"/>
            <a:ext cx="2442552" cy="966499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cords identified from: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Databases (n =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4681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gisters (n = 0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5" name="Rectangle 2">
            <a:extLst>
              <a:ext uri="{FF2B5EF4-FFF2-40B4-BE49-F238E27FC236}">
                <a16:creationId xmlns:a16="http://schemas.microsoft.com/office/drawing/2014/main" id="{5F15C9E8-2560-4433-A7CB-7082A352DC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5595" y="1456030"/>
            <a:ext cx="2848602" cy="768852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cords removed </a:t>
            </a:r>
            <a:r>
              <a:rPr kumimoji="0" lang="en-AU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before the screening</a:t>
            </a: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: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Duplicate records removed (n = 2382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6" name="Rectangle 3">
            <a:extLst>
              <a:ext uri="{FF2B5EF4-FFF2-40B4-BE49-F238E27FC236}">
                <a16:creationId xmlns:a16="http://schemas.microsoft.com/office/drawing/2014/main" id="{B85414B3-37CC-4AD6-AC09-1A36AA027C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0191" y="2079221"/>
            <a:ext cx="2442552" cy="685911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cords screened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2299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EE3B20AE-7B39-4F5A-AB1D-8A5EF9BDEE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5593" y="2627686"/>
            <a:ext cx="2853047" cy="685911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cords excluded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2220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9A4660FC-5A98-48EA-86A6-69E3D2E70C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749" y="3124256"/>
            <a:ext cx="2442551" cy="685911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sought for retrieval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77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FBA3DD2A-A303-4911-8EAB-D97479B464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3113" y="3716401"/>
            <a:ext cx="2805528" cy="474387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not retrieved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4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10" name="Rectangle 8">
            <a:extLst>
              <a:ext uri="{FF2B5EF4-FFF2-40B4-BE49-F238E27FC236}">
                <a16:creationId xmlns:a16="http://schemas.microsoft.com/office/drawing/2014/main" id="{9E07ECCF-EB20-4898-873D-2259A5E57C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153" y="4184905"/>
            <a:ext cx="2442552" cy="685911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assessed for eligibility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73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11" name="Rectangle 9">
            <a:extLst>
              <a:ext uri="{FF2B5EF4-FFF2-40B4-BE49-F238E27FC236}">
                <a16:creationId xmlns:a16="http://schemas.microsoft.com/office/drawing/2014/main" id="{A81FD659-7E51-4CB9-B334-6DCE9B556A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93112" y="4578027"/>
            <a:ext cx="3636338" cy="1794198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excluded: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mbria" panose="02040503050406030204" pitchFamily="18" charset="0"/>
                <a:ea typeface="Cambria" panose="02040503050406030204" pitchFamily="18" charset="0"/>
              </a:rPr>
              <a:t>Combination therapy (n=5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mbria" panose="02040503050406030204" pitchFamily="18" charset="0"/>
                <a:ea typeface="Cambria" panose="02040503050406030204" pitchFamily="18" charset="0"/>
              </a:rPr>
              <a:t>Human study (n=4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mbria" panose="02040503050406030204" pitchFamily="18" charset="0"/>
                <a:ea typeface="Cambria" panose="02040503050406030204" pitchFamily="18" charset="0"/>
              </a:rPr>
              <a:t>In-vitro study (n=9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mbria" panose="02040503050406030204" pitchFamily="18" charset="0"/>
                <a:ea typeface="Cambria" panose="02040503050406030204" pitchFamily="18" charset="0"/>
              </a:rPr>
              <a:t>Diabetic animals (n=2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mbria" panose="02040503050406030204" pitchFamily="18" charset="0"/>
                <a:ea typeface="Cambria" panose="02040503050406030204" pitchFamily="18" charset="0"/>
              </a:rPr>
              <a:t>Not reporting the required data (n=3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latin typeface="Cambria" panose="02040503050406030204" pitchFamily="18" charset="0"/>
                <a:ea typeface="Cambria" panose="02040503050406030204" pitchFamily="18" charset="0"/>
              </a:rPr>
              <a:t>Other animals (n=5)</a:t>
            </a:r>
          </a:p>
        </p:txBody>
      </p:sp>
      <p:sp>
        <p:nvSpPr>
          <p:cNvPr id="12" name="Rectangle 10">
            <a:extLst>
              <a:ext uri="{FF2B5EF4-FFF2-40B4-BE49-F238E27FC236}">
                <a16:creationId xmlns:a16="http://schemas.microsoft.com/office/drawing/2014/main" id="{A3288056-361F-48A5-B45B-04C0BFE6C1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3578" y="724430"/>
            <a:ext cx="2442551" cy="966499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cords identified from: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Google </a:t>
            </a:r>
            <a:r>
              <a:rPr lang="en-AU" altLang="en-US" sz="1200" dirty="0">
                <a:solidFill>
                  <a:srgbClr val="000000"/>
                </a:solidFill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and Google Scholar (n = 5)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ference Tracking (n = 1)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13" name="Rectangle 11">
            <a:extLst>
              <a:ext uri="{FF2B5EF4-FFF2-40B4-BE49-F238E27FC236}">
                <a16:creationId xmlns:a16="http://schemas.microsoft.com/office/drawing/2014/main" id="{590F3159-3E6F-4F0E-B80C-6197DEA97F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3577" y="3497406"/>
            <a:ext cx="2442552" cy="685911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assessed for eligibility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6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14" name="Rectangle 12">
            <a:extLst>
              <a:ext uri="{FF2B5EF4-FFF2-40B4-BE49-F238E27FC236}">
                <a16:creationId xmlns:a16="http://schemas.microsoft.com/office/drawing/2014/main" id="{154A5446-A73E-4DC5-BDAC-F8A3D67720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77130" y="4112365"/>
            <a:ext cx="2442552" cy="811460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excluded: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AU" altLang="en-US" sz="1200">
                <a:solidFill>
                  <a:srgbClr val="000000"/>
                </a:solidFill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0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ambria" panose="02040503050406030204" pitchFamily="18" charset="0"/>
              <a:ea typeface="Cambria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3">
            <a:extLst>
              <a:ext uri="{FF2B5EF4-FFF2-40B4-BE49-F238E27FC236}">
                <a16:creationId xmlns:a16="http://schemas.microsoft.com/office/drawing/2014/main" id="{219C44CB-5E92-4960-A031-DD4EABC554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6698" y="5616575"/>
            <a:ext cx="2442552" cy="942094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tudies included in the review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</a:t>
            </a:r>
            <a:r>
              <a:rPr lang="en-AU" altLang="en-US" sz="1200">
                <a:solidFill>
                  <a:srgbClr val="000000"/>
                </a:solidFill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51</a:t>
            </a:r>
            <a:r>
              <a:rPr kumimoji="0" lang="en-AU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6895B16-415D-49C9-910F-1F0713610B0C}"/>
              </a:ext>
            </a:extLst>
          </p:cNvPr>
          <p:cNvCxnSpPr>
            <a:cxnSpLocks/>
            <a:endCxn id="5" idx="1"/>
          </p:cNvCxnSpPr>
          <p:nvPr/>
        </p:nvCxnSpPr>
        <p:spPr>
          <a:xfrm flipV="1">
            <a:off x="1988429" y="1840456"/>
            <a:ext cx="1357166" cy="351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694190A9-62E9-49E0-85E7-31DB31462CF0}"/>
              </a:ext>
            </a:extLst>
          </p:cNvPr>
          <p:cNvCxnSpPr>
            <a:cxnSpLocks/>
            <a:endCxn id="7" idx="1"/>
          </p:cNvCxnSpPr>
          <p:nvPr/>
        </p:nvCxnSpPr>
        <p:spPr>
          <a:xfrm>
            <a:off x="1988429" y="2970642"/>
            <a:ext cx="135716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6BD995BD-1A61-4F0E-869F-CCAFBF94E4BA}"/>
              </a:ext>
            </a:extLst>
          </p:cNvPr>
          <p:cNvCxnSpPr>
            <a:cxnSpLocks/>
            <a:endCxn id="9" idx="1"/>
          </p:cNvCxnSpPr>
          <p:nvPr/>
        </p:nvCxnSpPr>
        <p:spPr>
          <a:xfrm flipV="1">
            <a:off x="1988429" y="3953595"/>
            <a:ext cx="1404684" cy="101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9FADDA17-01B7-4776-BA6D-F9D8D20ED0D0}"/>
              </a:ext>
            </a:extLst>
          </p:cNvPr>
          <p:cNvCxnSpPr>
            <a:cxnSpLocks/>
          </p:cNvCxnSpPr>
          <p:nvPr/>
        </p:nvCxnSpPr>
        <p:spPr>
          <a:xfrm>
            <a:off x="8044853" y="4500245"/>
            <a:ext cx="153227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sp>
        <p:nvSpPr>
          <p:cNvPr id="21" name="Flowchart: Alternate Process 29">
            <a:extLst>
              <a:ext uri="{FF2B5EF4-FFF2-40B4-BE49-F238E27FC236}">
                <a16:creationId xmlns:a16="http://schemas.microsoft.com/office/drawing/2014/main" id="{DA6A72AB-806A-4F0D-90CA-8A29EB97F6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7153" y="191044"/>
            <a:ext cx="4677751" cy="342955"/>
          </a:xfrm>
          <a:prstGeom prst="flowChartAlternateProcess">
            <a:avLst/>
          </a:prstGeom>
          <a:solidFill>
            <a:schemeClr val="accent4"/>
          </a:soli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dentification of studies via databases and registers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22" name="Flowchart: Alternate Process 30">
            <a:extLst>
              <a:ext uri="{FF2B5EF4-FFF2-40B4-BE49-F238E27FC236}">
                <a16:creationId xmlns:a16="http://schemas.microsoft.com/office/drawing/2014/main" id="{654F1DEF-3430-4269-AECA-FFCB91A9C25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3577" y="223011"/>
            <a:ext cx="4677752" cy="342955"/>
          </a:xfrm>
          <a:prstGeom prst="flowChartAlternateProcess">
            <a:avLst/>
          </a:prstGeom>
          <a:solidFill>
            <a:schemeClr val="accent4"/>
          </a:soli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dentification of studies via other methods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23" name="Flowchart: Alternate Process 31">
            <a:extLst>
              <a:ext uri="{FF2B5EF4-FFF2-40B4-BE49-F238E27FC236}">
                <a16:creationId xmlns:a16="http://schemas.microsoft.com/office/drawing/2014/main" id="{435C692D-6960-45FE-A560-7576C5EA6518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-122084" y="1315984"/>
            <a:ext cx="1185456" cy="341014"/>
          </a:xfrm>
          <a:prstGeom prst="flowChartAlternateProcess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dentification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24" name="Flowchart: Alternate Process 32">
            <a:extLst>
              <a:ext uri="{FF2B5EF4-FFF2-40B4-BE49-F238E27FC236}">
                <a16:creationId xmlns:a16="http://schemas.microsoft.com/office/drawing/2014/main" id="{62D5EC26-1266-4841-A222-DEAC96EE6CFF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-629699" y="3509523"/>
            <a:ext cx="2197507" cy="341012"/>
          </a:xfrm>
          <a:prstGeom prst="flowChartAlternateProcess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Screening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25" name="Flowchart: Alternate Process 33">
            <a:extLst>
              <a:ext uri="{FF2B5EF4-FFF2-40B4-BE49-F238E27FC236}">
                <a16:creationId xmlns:a16="http://schemas.microsoft.com/office/drawing/2014/main" id="{5066C52A-2FBE-41B6-8C6F-9943A397F11B}"/>
              </a:ext>
            </a:extLst>
          </p:cNvPr>
          <p:cNvSpPr>
            <a:spLocks noChangeArrowheads="1"/>
          </p:cNvSpPr>
          <p:nvPr/>
        </p:nvSpPr>
        <p:spPr bwMode="auto">
          <a:xfrm rot="-5400000">
            <a:off x="-56915" y="5917116"/>
            <a:ext cx="995810" cy="341012"/>
          </a:xfrm>
          <a:prstGeom prst="flowChartAlternateProcess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ncluded</a:t>
            </a:r>
            <a:endParaRPr kumimoji="0" lang="en-AU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E9F41CF3-BB86-426C-9C3B-03B6ECB0524B}"/>
              </a:ext>
            </a:extLst>
          </p:cNvPr>
          <p:cNvCxnSpPr>
            <a:cxnSpLocks/>
            <a:stCxn id="4" idx="2"/>
            <a:endCxn id="6" idx="0"/>
          </p:cNvCxnSpPr>
          <p:nvPr/>
        </p:nvCxnSpPr>
        <p:spPr>
          <a:xfrm>
            <a:off x="1977024" y="1608715"/>
            <a:ext cx="4443" cy="4705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9915A776-A1D9-4C49-801D-9A92027FDEA4}"/>
              </a:ext>
            </a:extLst>
          </p:cNvPr>
          <p:cNvCxnSpPr/>
          <p:nvPr/>
        </p:nvCxnSpPr>
        <p:spPr>
          <a:xfrm>
            <a:off x="1977024" y="2771174"/>
            <a:ext cx="0" cy="3660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9C642432-26FA-4BA1-B976-93B7D7F71BF9}"/>
              </a:ext>
            </a:extLst>
          </p:cNvPr>
          <p:cNvCxnSpPr/>
          <p:nvPr/>
        </p:nvCxnSpPr>
        <p:spPr>
          <a:xfrm>
            <a:off x="1977024" y="3824694"/>
            <a:ext cx="0" cy="3660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29" name="Connector: Elbow 28">
            <a:extLst>
              <a:ext uri="{FF2B5EF4-FFF2-40B4-BE49-F238E27FC236}">
                <a16:creationId xmlns:a16="http://schemas.microsoft.com/office/drawing/2014/main" id="{327CDF2C-1FF6-4151-866E-1D1E6DE89872}"/>
              </a:ext>
            </a:extLst>
          </p:cNvPr>
          <p:cNvCxnSpPr>
            <a:cxnSpLocks/>
            <a:stCxn id="13" idx="2"/>
          </p:cNvCxnSpPr>
          <p:nvPr/>
        </p:nvCxnSpPr>
        <p:spPr>
          <a:xfrm rot="5400000">
            <a:off x="4499486" y="2893536"/>
            <a:ext cx="2255586" cy="4835148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3CB14B54-8345-4AEA-BCD0-E86A41F7489E}"/>
              </a:ext>
            </a:extLst>
          </p:cNvPr>
          <p:cNvCxnSpPr>
            <a:cxnSpLocks/>
            <a:stCxn id="10" idx="2"/>
          </p:cNvCxnSpPr>
          <p:nvPr/>
        </p:nvCxnSpPr>
        <p:spPr>
          <a:xfrm>
            <a:off x="1988429" y="4870816"/>
            <a:ext cx="0" cy="7087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sp>
        <p:nvSpPr>
          <p:cNvPr id="31" name="Rectangle 7">
            <a:extLst>
              <a:ext uri="{FF2B5EF4-FFF2-40B4-BE49-F238E27FC236}">
                <a16:creationId xmlns:a16="http://schemas.microsoft.com/office/drawing/2014/main" id="{DDE04602-1DD1-4A66-B0B4-C137917D0F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3577" y="2433727"/>
            <a:ext cx="2442552" cy="685911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sought for retrieval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6)</a:t>
            </a:r>
            <a:endParaRPr kumimoji="0" lang="en-AU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sp>
        <p:nvSpPr>
          <p:cNvPr id="32" name="Rectangle 20">
            <a:extLst>
              <a:ext uri="{FF2B5EF4-FFF2-40B4-BE49-F238E27FC236}">
                <a16:creationId xmlns:a16="http://schemas.microsoft.com/office/drawing/2014/main" id="{6899FB53-095A-4D70-A237-8011BEB059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9610393" y="2951839"/>
            <a:ext cx="2442552" cy="685911"/>
          </a:xfrm>
          <a:prstGeom prst="rect">
            <a:avLst/>
          </a:prstGeom>
          <a:gradFill flip="none" rotWithShape="1">
            <a:gsLst>
              <a:gs pos="0">
                <a:schemeClr val="accent4">
                  <a:lumMod val="0"/>
                  <a:lumOff val="100000"/>
                </a:schemeClr>
              </a:gs>
              <a:gs pos="91000">
                <a:schemeClr val="accent4">
                  <a:lumMod val="0"/>
                  <a:lumOff val="100000"/>
                </a:schemeClr>
              </a:gs>
              <a:gs pos="100000">
                <a:srgbClr val="92D050"/>
              </a:gs>
            </a:gsLst>
            <a:lin ang="2700000" scaled="1"/>
            <a:tileRect/>
          </a:gradFill>
          <a:ln>
            <a:solidFill>
              <a:schemeClr val="tx1"/>
            </a:solidFill>
            <a:headEnd/>
            <a:tailEnd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Reports not retrieved</a:t>
            </a:r>
            <a:endParaRPr kumimoji="0" lang="en-AU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n = 0)</a:t>
            </a:r>
            <a:endParaRPr kumimoji="0" lang="en-AU" altLang="en-US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70EEC6F1-8804-4F37-8C58-9ACBA26FE086}"/>
              </a:ext>
            </a:extLst>
          </p:cNvPr>
          <p:cNvCxnSpPr>
            <a:cxnSpLocks/>
          </p:cNvCxnSpPr>
          <p:nvPr/>
        </p:nvCxnSpPr>
        <p:spPr>
          <a:xfrm>
            <a:off x="8044853" y="3294795"/>
            <a:ext cx="15655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66FDE59D-2DF6-453D-9BE0-14A17739BCF6}"/>
              </a:ext>
            </a:extLst>
          </p:cNvPr>
          <p:cNvCxnSpPr/>
          <p:nvPr/>
        </p:nvCxnSpPr>
        <p:spPr>
          <a:xfrm>
            <a:off x="8049886" y="3130550"/>
            <a:ext cx="0" cy="3660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52131C36-8543-4E2F-935E-37673D431F40}"/>
              </a:ext>
            </a:extLst>
          </p:cNvPr>
          <p:cNvCxnSpPr>
            <a:cxnSpLocks/>
          </p:cNvCxnSpPr>
          <p:nvPr/>
        </p:nvCxnSpPr>
        <p:spPr>
          <a:xfrm>
            <a:off x="8044853" y="1690929"/>
            <a:ext cx="0" cy="73124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F34364AE-5618-4089-96D1-B5E8DB02AFC1}"/>
              </a:ext>
            </a:extLst>
          </p:cNvPr>
          <p:cNvCxnSpPr>
            <a:cxnSpLocks/>
          </p:cNvCxnSpPr>
          <p:nvPr/>
        </p:nvCxnSpPr>
        <p:spPr>
          <a:xfrm>
            <a:off x="1988429" y="5170010"/>
            <a:ext cx="140468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</p:cxnSp>
    </p:spTree>
    <p:extLst>
      <p:ext uri="{BB962C8B-B14F-4D97-AF65-F5344CB8AC3E}">
        <p14:creationId xmlns:p14="http://schemas.microsoft.com/office/powerpoint/2010/main" val="5392327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9</TotalTime>
  <Words>198</Words>
  <Application>Microsoft Office PowerPoint</Application>
  <PresentationFormat>Widescreen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usefifard</dc:creator>
  <cp:lastModifiedBy>Hamed Zarei</cp:lastModifiedBy>
  <cp:revision>48</cp:revision>
  <dcterms:created xsi:type="dcterms:W3CDTF">2021-08-30T19:26:24Z</dcterms:created>
  <dcterms:modified xsi:type="dcterms:W3CDTF">2024-05-19T19:25:42Z</dcterms:modified>
</cp:coreProperties>
</file>